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8BFE5ECC-C894-41D0-AB58-63CEA6538AB4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212C326D-539F-4C55-B6B5-7851B48BAA22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9BA47-6DA1-4C89-B892-F85733A71B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79A54-E8FA-467D-83A4-DD4428F31E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AC7245-2A74-4AE7-B6DD-D24D79F4FA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3AC2E3-D0B8-4C91-958F-CE36342DAF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09F6B-950D-4598-A9ED-39EA7D756B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2E0BF1-09E3-4279-99BB-D490753694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592D4-DCE4-4225-8D43-77AE955AB2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B48A57-A48C-443B-917C-71626E819A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5AA0EE-DE78-4F83-8559-6E96AB49A0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0E2FD-4774-4A71-B1B6-8CDD191644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97F95-35FE-4819-869F-56CDE06F4C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E268C-27D0-4332-AFAE-5284C9F3EB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408FE335-5CDE-43A0-91AE-C7C5BB405D07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Graphique 9" descr=""/>
          <p:cNvPicPr/>
          <p:nvPr/>
        </p:nvPicPr>
        <p:blipFill>
          <a:blip r:embed="rId1"/>
          <a:stretch/>
        </p:blipFill>
        <p:spPr>
          <a:xfrm>
            <a:off x="1395360" y="182520"/>
            <a:ext cx="7212240" cy="512784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2"/>
          <p:cNvSpPr/>
          <p:nvPr/>
        </p:nvSpPr>
        <p:spPr>
          <a:xfrm>
            <a:off x="228600" y="5202360"/>
            <a:ext cx="8321760" cy="79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2640" rIns="62640" tIns="31320" bIns="3132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Figure S2. Percentage of transcription factors regulated in </a:t>
            </a:r>
            <a:r>
              <a:rPr b="1" i="1" lang="en-US" sz="1600" spc="-1" strike="noStrike">
                <a:solidFill>
                  <a:srgbClr val="000000"/>
                </a:solidFill>
                <a:latin typeface="Times New Roman"/>
              </a:rPr>
              <a:t>C.glauca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 nodule and mycorrhizae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br>
              <a:rPr sz="1600"/>
            </a:b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09T11:44:30Z</dcterms:created>
  <dc:creator>diedhiou</dc:creator>
  <dc:description/>
  <dc:language>en-US</dc:language>
  <cp:lastModifiedBy>diedhiou</cp:lastModifiedBy>
  <dcterms:modified xsi:type="dcterms:W3CDTF">2014-07-25T13:12:54Z</dcterms:modified>
  <cp:revision>5</cp:revision>
  <dc:subject/>
  <dc:title>Diapositive 1</dc:title>
</cp:coreProperties>
</file>